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2AC833-A2AF-443D-A98A-895ECA7DCAF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D64DEF-574A-41A3-AC93-56FA4E0F4C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34B288-1F00-4FFF-A2CC-B9367C6A5DF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3A1ED8-6A63-4E50-A038-0171B94C58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DA2D55-B82C-4F08-B40A-2F7CDD7EC7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49AE9-EB87-4BFE-82FD-C737167E60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528DD7-771E-4FB6-852A-A1654784BB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0E278D-412B-493C-A180-2DDA8F69CD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DD58F-39B9-4400-8B32-B4A435640B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E06E48-0F0D-42DE-87C8-3FA32661C59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DD6DA-98A4-4EA8-8C31-ED1A155261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C97C6-D65A-415F-8AD9-F3DC77C8B9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87016F-44F8-490A-940D-6C34EAB18524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508040" y="1387440"/>
            <a:ext cx="6123240" cy="40813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326880" y="5584680"/>
            <a:ext cx="8034480" cy="84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800" rIns="82800" tIns="41400" bIns="414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Fig 5. Funnel plot showing the association between Standard Error of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[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SE(MD)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] and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(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MD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) as it was calculated by the fixed effect mode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492360" y="333360"/>
            <a:ext cx="2000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TNF</a:t>
            </a: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-α</a:t>
            </a:r>
            <a:r>
              <a:rPr b="0" lang="en-US" sz="1800" spc="-1" strike="noStrike">
                <a:solidFill>
                  <a:srgbClr val="ffffff"/>
                </a:solidFill>
                <a:latin typeface="Times New Roman"/>
              </a:rPr>
              <a:t> and GDM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508040" y="1387440"/>
            <a:ext cx="6123240" cy="40813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3925080" y="371520"/>
            <a:ext cx="1614240" cy="30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Leptin  and GD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26880" y="5584680"/>
            <a:ext cx="8034480" cy="84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800" rIns="82800" tIns="41400" bIns="414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Fig 6. Funnel plot showing the association between Standard Error of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[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SE(MD)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] and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(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MD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) as it was calculated by the fixed effect mode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"/>
          <p:cNvSpPr/>
          <p:nvPr/>
        </p:nvSpPr>
        <p:spPr>
          <a:xfrm>
            <a:off x="3348720" y="476280"/>
            <a:ext cx="2089440" cy="30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82800" rIns="82800" tIns="41400" bIns="414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0" lang="zh-CN" sz="1600" spc="-1" strike="noStrike">
                <a:solidFill>
                  <a:srgbClr val="000000"/>
                </a:solidFill>
                <a:latin typeface="Times New Roman"/>
              </a:rPr>
              <a:t>Adiponectin  and GD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1893960" y="1339920"/>
            <a:ext cx="6122880" cy="408312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26880" y="5584680"/>
            <a:ext cx="8034480" cy="84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82800" rIns="82800" tIns="41400" bIns="414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828720"/>
                <a:tab algn="l" pos="1657440"/>
                <a:tab algn="l" pos="2486160"/>
                <a:tab algn="l" pos="3314880"/>
                <a:tab algn="l" pos="4143240"/>
                <a:tab algn="l" pos="4971960"/>
                <a:tab algn="l" pos="5800680"/>
                <a:tab algn="l" pos="6629400"/>
                <a:tab algn="l" pos="7458120"/>
                <a:tab algn="l" pos="8286840"/>
                <a:tab algn="l" pos="9115560"/>
                <a:tab algn="l" pos="9944280"/>
                <a:tab algn="l" pos="10772640"/>
              </a:tabLst>
            </a:pP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Fig 7. Funnel plot showing the association between Standard Error of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[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SE(MD)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] and </a:t>
            </a:r>
            <a:r>
              <a:rPr b="1" i="1" lang="en-US" sz="1800" spc="-1" strike="noStrike">
                <a:solidFill>
                  <a:srgbClr val="ffffff"/>
                </a:solidFill>
                <a:latin typeface="Times New Roman"/>
              </a:rPr>
              <a:t>mean difference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 (</a:t>
            </a:r>
            <a:r>
              <a:rPr b="1" lang="zh-CN" sz="1800" spc="-1" strike="noStrike">
                <a:solidFill>
                  <a:srgbClr val="ffffff"/>
                </a:solidFill>
                <a:latin typeface="Times New Roman"/>
              </a:rPr>
              <a:t>MD</a:t>
            </a:r>
            <a:r>
              <a:rPr b="1" i="1" lang="zh-CN" sz="1800" spc="-1" strike="noStrike">
                <a:solidFill>
                  <a:srgbClr val="ffffff"/>
                </a:solidFill>
                <a:latin typeface="Times New Roman"/>
              </a:rPr>
              <a:t>) as it was calculated by the fixed effect mode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8-17T11:52:25Z</dcterms:created>
  <dc:creator>walkinnet</dc:creator>
  <dc:description/>
  <dc:language>en-US</dc:language>
  <cp:lastModifiedBy>User</cp:lastModifiedBy>
  <dcterms:modified xsi:type="dcterms:W3CDTF">2013-12-23T07:46:37Z</dcterms:modified>
  <cp:revision>3</cp:revision>
  <dc:subject/>
  <dc:title>幻灯片 1</dc:title>
</cp:coreProperties>
</file>